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1478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788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354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483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807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99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705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233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865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581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942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672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9C8EF8-2EFB-40AC-8213-E7C9EB220ADF}" type="datetimeFigureOut">
              <a:rPr lang="en-US" smtClean="0"/>
              <a:t>4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23A4D7-F722-4855-96A4-D869ECF012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020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1A9C91D7-8C9A-4FCE-B10B-C69011650033}"/>
              </a:ext>
            </a:extLst>
          </p:cNvPr>
          <p:cNvSpPr txBox="1"/>
          <p:nvPr/>
        </p:nvSpPr>
        <p:spPr>
          <a:xfrm>
            <a:off x="1588703" y="3523925"/>
            <a:ext cx="1778605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OSCP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1F6B283-1AB9-43B4-BF36-3C5F801B0E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7142" y="801196"/>
            <a:ext cx="1399355" cy="11897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4D72144-39CF-477E-875B-80D8E2193DD0}"/>
              </a:ext>
            </a:extLst>
          </p:cNvPr>
          <p:cNvSpPr txBox="1"/>
          <p:nvPr/>
        </p:nvSpPr>
        <p:spPr>
          <a:xfrm>
            <a:off x="4789938" y="1997110"/>
            <a:ext cx="1462251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ND-5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2864C39-F8A6-4AF3-8943-3A1D139C2899}"/>
              </a:ext>
            </a:extLst>
          </p:cNvPr>
          <p:cNvSpPr txBox="1"/>
          <p:nvPr/>
        </p:nvSpPr>
        <p:spPr>
          <a:xfrm>
            <a:off x="6153200" y="1997110"/>
            <a:ext cx="1778605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 err="1">
                <a:latin typeface="Arial" panose="020B0604020202020204" pitchFamily="34" charset="0"/>
                <a:cs typeface="Arial" panose="020B0604020202020204" pitchFamily="34" charset="0"/>
              </a:rPr>
              <a:t>ATPsynC</a:t>
            </a:r>
            <a:endParaRPr lang="en-US" sz="96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364AC9-F341-4136-98DF-3AFFFE21A921}"/>
              </a:ext>
            </a:extLst>
          </p:cNvPr>
          <p:cNvSpPr txBox="1"/>
          <p:nvPr/>
        </p:nvSpPr>
        <p:spPr>
          <a:xfrm>
            <a:off x="1784247" y="1997110"/>
            <a:ext cx="1462251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 err="1">
                <a:latin typeface="Arial" panose="020B0604020202020204" pitchFamily="34" charset="0"/>
                <a:cs typeface="Arial" panose="020B0604020202020204" pitchFamily="34" charset="0"/>
              </a:rPr>
              <a:t>MgstI</a:t>
            </a:r>
            <a:endParaRPr lang="en-US" sz="96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4F0F44-CDF0-4898-8E3C-07A07E3C8548}"/>
              </a:ext>
            </a:extLst>
          </p:cNvPr>
          <p:cNvSpPr txBox="1"/>
          <p:nvPr/>
        </p:nvSpPr>
        <p:spPr>
          <a:xfrm>
            <a:off x="3277978" y="1997110"/>
            <a:ext cx="1462251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TFAM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49C0FAF-6AFA-4609-AF8E-21359BE4D9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17432" y="801196"/>
            <a:ext cx="1390484" cy="11897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73F1279-05B8-4ECF-892D-2035ADF664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6603" y="801195"/>
            <a:ext cx="1404899" cy="11886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33DF713-EA68-426B-A837-B7276CA035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46920" y="798401"/>
            <a:ext cx="1411551" cy="1190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9E0EF6E-595B-4523-A00A-9D212B39FA3D}"/>
              </a:ext>
            </a:extLst>
          </p:cNvPr>
          <p:cNvSpPr txBox="1"/>
          <p:nvPr/>
        </p:nvSpPr>
        <p:spPr>
          <a:xfrm>
            <a:off x="1219508" y="817287"/>
            <a:ext cx="8121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SIN3 18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C46DC20-7A7B-4CB2-84C5-A755EAAC8741}"/>
              </a:ext>
            </a:extLst>
          </p:cNvPr>
          <p:cNvSpPr txBox="1"/>
          <p:nvPr/>
        </p:nvSpPr>
        <p:spPr>
          <a:xfrm>
            <a:off x="1219508" y="1285648"/>
            <a:ext cx="8121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SIN3 2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BFD1BD6-1657-470E-8926-F48B2037B001}"/>
              </a:ext>
            </a:extLst>
          </p:cNvPr>
          <p:cNvSpPr txBox="1"/>
          <p:nvPr/>
        </p:nvSpPr>
        <p:spPr>
          <a:xfrm>
            <a:off x="1411107" y="1531258"/>
            <a:ext cx="6205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E8F1326-ACC2-4D62-9537-F979BB0217F4}"/>
              </a:ext>
            </a:extLst>
          </p:cNvPr>
          <p:cNvSpPr txBox="1"/>
          <p:nvPr/>
        </p:nvSpPr>
        <p:spPr>
          <a:xfrm>
            <a:off x="888933" y="1652019"/>
            <a:ext cx="1142749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Input SIN2 18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FA111C-F6DA-4678-966E-47A461F06EF8}"/>
              </a:ext>
            </a:extLst>
          </p:cNvPr>
          <p:cNvSpPr txBox="1"/>
          <p:nvPr/>
        </p:nvSpPr>
        <p:spPr>
          <a:xfrm>
            <a:off x="888933" y="1820423"/>
            <a:ext cx="1142749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Input SIN2 220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90238C5-0FDD-4972-8002-9BBC63593A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7142" y="2319925"/>
            <a:ext cx="1399355" cy="11908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79E18CE-4012-4BA9-B794-5162A1B22498}"/>
              </a:ext>
            </a:extLst>
          </p:cNvPr>
          <p:cNvSpPr txBox="1"/>
          <p:nvPr/>
        </p:nvSpPr>
        <p:spPr>
          <a:xfrm>
            <a:off x="3120568" y="3521385"/>
            <a:ext cx="1778605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Dron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1E10236-83E9-4BCD-946C-BACF16601FBD}"/>
              </a:ext>
            </a:extLst>
          </p:cNvPr>
          <p:cNvSpPr txBox="1"/>
          <p:nvPr/>
        </p:nvSpPr>
        <p:spPr>
          <a:xfrm>
            <a:off x="4648488" y="3516305"/>
            <a:ext cx="1778605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7D427F3-A956-4F6F-87BC-0ED55D0B5F58}"/>
              </a:ext>
            </a:extLst>
          </p:cNvPr>
          <p:cNvSpPr txBox="1"/>
          <p:nvPr/>
        </p:nvSpPr>
        <p:spPr>
          <a:xfrm>
            <a:off x="6153200" y="3516305"/>
            <a:ext cx="1778605" cy="24019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961" i="1" dirty="0">
                <a:latin typeface="Arial" panose="020B0604020202020204" pitchFamily="34" charset="0"/>
                <a:cs typeface="Arial" panose="020B0604020202020204" pitchFamily="34" charset="0"/>
              </a:rPr>
              <a:t>Diap1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2649D4F-172B-4C5B-917E-03B27B64099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11089" y="2319923"/>
            <a:ext cx="1396027" cy="11953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D3F7324-5BD6-4210-9191-A8362343549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84814" y="2316053"/>
            <a:ext cx="1391593" cy="11975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D2A9E16-F79D-40D5-9901-878607FF51E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38982" y="2311661"/>
            <a:ext cx="1407116" cy="12008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6F457343-1C64-4F34-99A5-27185D9DBC3B}"/>
              </a:ext>
            </a:extLst>
          </p:cNvPr>
          <p:cNvSpPr txBox="1"/>
          <p:nvPr/>
        </p:nvSpPr>
        <p:spPr>
          <a:xfrm>
            <a:off x="1219508" y="2338572"/>
            <a:ext cx="8121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SIN3 18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51C160D-8E27-40B3-B9E4-11BDCECF56D8}"/>
              </a:ext>
            </a:extLst>
          </p:cNvPr>
          <p:cNvSpPr txBox="1"/>
          <p:nvPr/>
        </p:nvSpPr>
        <p:spPr>
          <a:xfrm>
            <a:off x="1219508" y="2799950"/>
            <a:ext cx="8121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SIN3 22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4B2F027-E093-4D86-BA97-CBC0DAB20564}"/>
              </a:ext>
            </a:extLst>
          </p:cNvPr>
          <p:cNvSpPr txBox="1"/>
          <p:nvPr/>
        </p:nvSpPr>
        <p:spPr>
          <a:xfrm>
            <a:off x="1411107" y="3052544"/>
            <a:ext cx="620575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CDCA258-C7EE-4887-934F-B65608E05495}"/>
              </a:ext>
            </a:extLst>
          </p:cNvPr>
          <p:cNvSpPr txBox="1"/>
          <p:nvPr/>
        </p:nvSpPr>
        <p:spPr>
          <a:xfrm>
            <a:off x="888933" y="3173305"/>
            <a:ext cx="1142749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Input SIN2 18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CBC4111-0827-4110-A841-065D80DD2F90}"/>
              </a:ext>
            </a:extLst>
          </p:cNvPr>
          <p:cNvSpPr txBox="1"/>
          <p:nvPr/>
        </p:nvSpPr>
        <p:spPr>
          <a:xfrm>
            <a:off x="888933" y="3341711"/>
            <a:ext cx="1142749" cy="240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1" dirty="0">
                <a:latin typeface="Arial" panose="020B0604020202020204" pitchFamily="34" charset="0"/>
                <a:cs typeface="Arial" panose="020B0604020202020204" pitchFamily="34" charset="0"/>
              </a:rPr>
              <a:t>Input SIN2 22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8AD17B-D147-48EC-A94D-838E2BB008CA}"/>
              </a:ext>
            </a:extLst>
          </p:cNvPr>
          <p:cNvSpPr txBox="1"/>
          <p:nvPr/>
        </p:nvSpPr>
        <p:spPr>
          <a:xfrm>
            <a:off x="289838" y="454133"/>
            <a:ext cx="27066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</a:p>
        </p:txBody>
      </p:sp>
    </p:spTree>
    <p:extLst>
      <p:ext uri="{BB962C8B-B14F-4D97-AF65-F5344CB8AC3E}">
        <p14:creationId xmlns:p14="http://schemas.microsoft.com/office/powerpoint/2010/main" val="1546555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33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ndita Mitra</dc:creator>
  <cp:lastModifiedBy>Anindita Mitra</cp:lastModifiedBy>
  <cp:revision>7</cp:revision>
  <dcterms:created xsi:type="dcterms:W3CDTF">2022-03-10T20:04:21Z</dcterms:created>
  <dcterms:modified xsi:type="dcterms:W3CDTF">2022-04-08T14:56:34Z</dcterms:modified>
</cp:coreProperties>
</file>